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60" d="100"/>
          <a:sy n="60" d="100"/>
        </p:scale>
        <p:origin x="884" y="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5475ED-1851-4895-B4D6-9CD4554C10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5221C36-322F-4020-9326-D63E6DAED9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3C03B50-694A-4FD8-93A1-2F2779887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0F991-26CC-4C82-8F0F-60BEFD51CD1C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28FDD9F-9383-4A3A-8863-73C4BFEA38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E633DFE-E338-411B-86C8-C992B7AB1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013F-0747-4C73-A516-D8F0C95AF7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140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58FB86-8F7A-4019-B0E5-27DF8B2D5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669FBCC-F4C9-4726-8388-AF75BD7661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3E9A26-0A54-43F7-A2DF-8FDDB63AC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0F991-26CC-4C82-8F0F-60BEFD51CD1C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318547-AA7F-4AD1-BC25-FF6422125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8AFAEE-2268-4F66-8C37-892B84EA04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013F-0747-4C73-A516-D8F0C95AF7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0852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572A56F-896A-4E81-826F-5BF74FCBE0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585EDB8-B62C-4049-AAA7-C1E7F82734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6D0B30-77C3-4036-A54F-801CAEB1E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0F991-26CC-4C82-8F0F-60BEFD51CD1C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32C02F-33CA-4371-884C-76CD3E988E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A325164-CB60-41EC-B1D1-1F86BD020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013F-0747-4C73-A516-D8F0C95AF7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3565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47EDB2-424B-4D22-AD95-4155222FA9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FD16BA9-F07B-4769-9E7F-AFD84FFFB5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38AA3E-55A3-412B-B7F3-A1E4C93EF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0F991-26CC-4C82-8F0F-60BEFD51CD1C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DD407F-91D5-43EB-889D-B357BF262D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29BB6DD-543C-4573-B1DC-1B2787337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013F-0747-4C73-A516-D8F0C95AF7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6779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01F6E6-312D-44B1-9028-171BC8E0AD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D0606A0-C396-4D88-A130-3313DBEC5B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BEBF6B4-3A7F-4794-8376-37E3708B9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0F991-26CC-4C82-8F0F-60BEFD51CD1C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C5B38D-03E1-476D-9B6C-81A588DA2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E8408EB-64B0-4DE8-92DA-8CF04FA001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013F-0747-4C73-A516-D8F0C95AF7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5746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DFCB9F-EF59-48B6-BAB8-8A8B737030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D1EE7BD-8891-4487-A4A1-220010879E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B2BC367-2A28-44A6-BF6B-601E20B3C9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A364584-7F6B-4E75-9652-43B7E4E2E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0F991-26CC-4C82-8F0F-60BEFD51CD1C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E42F460-92EA-4049-A1F3-9F71423DF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EF2182-1A30-4863-AC03-801AC0D4AB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013F-0747-4C73-A516-D8F0C95AF7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824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F773E9-0953-4A8B-96DF-E3EAC1984B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2223B1D-E441-4F90-A5F2-BBE549EC40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2F3D14-1124-4BE1-A4EC-8D63D26DE1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FC02C94-BA5D-4A5E-9730-48D2B75743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5DA6BDD-408D-4E42-AE4C-F0B3252AF7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4E041C0-AAF0-4AFF-A308-F21D19C60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0F991-26CC-4C82-8F0F-60BEFD51CD1C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5869A2F-FA57-44DE-A5A5-51CFEF5E2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5433B6D-06A3-49B3-86A9-82FA4A370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013F-0747-4C73-A516-D8F0C95AF7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5909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331A7D-E2F6-4A41-94B9-66A333E242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8316A4D-0D68-47A6-A575-66BABE866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0F991-26CC-4C82-8F0F-60BEFD51CD1C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B6860F5-D5E0-4484-BB00-8C898AAE0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0A0C1F5-096A-4F7F-B83D-9330119E0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013F-0747-4C73-A516-D8F0C95AF7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358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2DE8BC7-CF72-4D2C-BF5A-862D86233B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0F991-26CC-4C82-8F0F-60BEFD51CD1C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986C2F7-ABF8-48DE-9467-2EFAADCF9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286D720-D76C-49C9-9957-503245A8F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013F-0747-4C73-A516-D8F0C95AF7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07530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CC2488-8485-400D-BB53-3670575659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9915181-2BBE-44F6-B199-3EB7B6A0BE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448F010-B5D4-4B7F-9FBC-BBC7B0CAE9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CF524E8-0AFF-4909-AF21-284D113708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0F991-26CC-4C82-8F0F-60BEFD51CD1C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09E232B-CD1E-49A3-B6C7-395E9DFF0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BF3A678-14F0-421D-B922-0744593E4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013F-0747-4C73-A516-D8F0C95AF7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5078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334264-4169-47B3-B145-5AEB172910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FAAD0CB-6746-4507-88AE-C39505FE22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2C0285A-04BA-465C-8B6C-FDA787DF7C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F8AB496-427F-436B-9AFC-FDB30C5D8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0F991-26CC-4C82-8F0F-60BEFD51CD1C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965A11E-9916-4BEA-B841-B98E688FD4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24C9994-7ACB-41D6-8323-802D860BA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013F-0747-4C73-A516-D8F0C95AF7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6292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6A42B88-1DFF-45AD-AD7F-3C293C3C89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F25A897-767D-46B3-8CB1-234700537A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64C373-B2FD-464F-B765-95D1BD5F6D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40F991-26CC-4C82-8F0F-60BEFD51CD1C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C16E5C7-C64E-468A-9443-59F5CEA321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79C141-8419-4A5A-83DF-ABCB21EFA0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03013F-0747-4C73-A516-D8F0C95AF7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1035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标题 5">
            <a:extLst>
              <a:ext uri="{FF2B5EF4-FFF2-40B4-BE49-F238E27FC236}">
                <a16:creationId xmlns:a16="http://schemas.microsoft.com/office/drawing/2014/main" id="{AE2BCB82-3F56-477A-A33D-131CC12ABB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CN" sz="2400">
                <a:latin typeface="Arial" panose="020B0604020202020204" pitchFamily="34" charset="0"/>
                <a:cs typeface="Arial" panose="020B0604020202020204" pitchFamily="34" charset="0"/>
              </a:rPr>
              <a:t>Meta-analysis of the sex differences in survival from OHCA to admission.</a:t>
            </a:r>
            <a:endParaRPr lang="zh-CN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内容占位符 8" descr="电脑萤幕画面&#10;&#10;描述已自动生成">
            <a:extLst>
              <a:ext uri="{FF2B5EF4-FFF2-40B4-BE49-F238E27FC236}">
                <a16:creationId xmlns:a16="http://schemas.microsoft.com/office/drawing/2014/main" id="{AC7A9FAC-3642-4514-A79F-1DF5876707A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2496" y="1825625"/>
            <a:ext cx="6527007" cy="4351338"/>
          </a:xfrm>
        </p:spPr>
      </p:pic>
    </p:spTree>
    <p:extLst>
      <p:ext uri="{BB962C8B-B14F-4D97-AF65-F5344CB8AC3E}">
        <p14:creationId xmlns:p14="http://schemas.microsoft.com/office/powerpoint/2010/main" val="35409227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EDDAD6-1482-4C1B-BD89-3E7089A830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altLang="zh-CN" sz="2400">
                <a:latin typeface="Arial" panose="020B0604020202020204" pitchFamily="34" charset="0"/>
                <a:cs typeface="Arial" panose="020B0604020202020204" pitchFamily="34" charset="0"/>
              </a:rPr>
              <a:t> Meta-analysis of the sex differences in survival from admission to discharge.</a:t>
            </a:r>
            <a:endParaRPr lang="zh-CN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内容占位符 4" descr="图片包含 黑色, 绿色, 桌子, 红色&#10;&#10;描述已自动生成">
            <a:extLst>
              <a:ext uri="{FF2B5EF4-FFF2-40B4-BE49-F238E27FC236}">
                <a16:creationId xmlns:a16="http://schemas.microsoft.com/office/drawing/2014/main" id="{7D120682-0DC7-4790-96F2-618D0C16B6D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2496" y="1825625"/>
            <a:ext cx="6527007" cy="4351338"/>
          </a:xfrm>
        </p:spPr>
      </p:pic>
    </p:spTree>
    <p:extLst>
      <p:ext uri="{BB962C8B-B14F-4D97-AF65-F5344CB8AC3E}">
        <p14:creationId xmlns:p14="http://schemas.microsoft.com/office/powerpoint/2010/main" val="40088244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84B5DF-D09F-4358-BB0C-1F4130DA9E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altLang="zh-CN" sz="2400">
                <a:latin typeface="Arial" panose="020B0604020202020204" pitchFamily="34" charset="0"/>
                <a:cs typeface="Arial" panose="020B0604020202020204" pitchFamily="34" charset="0"/>
              </a:rPr>
              <a:t>Meta-analysis of the sex differences in survival from OHCA to discharge</a:t>
            </a:r>
            <a:endParaRPr lang="zh-CN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内容占位符 4" descr="电脑萤幕画面&#10;&#10;描述已自动生成">
            <a:extLst>
              <a:ext uri="{FF2B5EF4-FFF2-40B4-BE49-F238E27FC236}">
                <a16:creationId xmlns:a16="http://schemas.microsoft.com/office/drawing/2014/main" id="{DAB24848-5BB7-433E-B34C-C315B25A16C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2496" y="1825625"/>
            <a:ext cx="6527007" cy="4351338"/>
          </a:xfrm>
        </p:spPr>
      </p:pic>
    </p:spTree>
    <p:extLst>
      <p:ext uri="{BB962C8B-B14F-4D97-AF65-F5344CB8AC3E}">
        <p14:creationId xmlns:p14="http://schemas.microsoft.com/office/powerpoint/2010/main" val="12290778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EC7E31-9ACA-4B9A-9D77-3CCFBEB82E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CN" sz="2800">
                <a:latin typeface="Arial" panose="020B0604020202020204" pitchFamily="34" charset="0"/>
                <a:cs typeface="Arial" panose="020B0604020202020204" pitchFamily="34" charset="0"/>
              </a:rPr>
              <a:t>Meta-analysis of the sex differences in neurological prognosis.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内容占位符 4" descr="电脑萤幕画面&#10;&#10;描述已自动生成">
            <a:extLst>
              <a:ext uri="{FF2B5EF4-FFF2-40B4-BE49-F238E27FC236}">
                <a16:creationId xmlns:a16="http://schemas.microsoft.com/office/drawing/2014/main" id="{DF8876FC-CB18-4B40-A999-B11DA6D836B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2496" y="1825625"/>
            <a:ext cx="6527007" cy="4351338"/>
          </a:xfrm>
        </p:spPr>
      </p:pic>
    </p:spTree>
    <p:extLst>
      <p:ext uri="{BB962C8B-B14F-4D97-AF65-F5344CB8AC3E}">
        <p14:creationId xmlns:p14="http://schemas.microsoft.com/office/powerpoint/2010/main" val="2466686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5</Words>
  <Application>Microsoft Office PowerPoint</Application>
  <PresentationFormat>宽屏</PresentationFormat>
  <Paragraphs>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Meta-analysis of the sex differences in survival from OHCA to admission.</vt:lpstr>
      <vt:lpstr> Meta-analysis of the sex differences in survival from admission to discharge.</vt:lpstr>
      <vt:lpstr>Meta-analysis of the sex differences in survival from OHCA to discharge</vt:lpstr>
      <vt:lpstr>Meta-analysis of the sex differences in neurological prognosis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i Hao</dc:creator>
  <cp:lastModifiedBy>Lei Hao</cp:lastModifiedBy>
  <cp:revision>4</cp:revision>
  <dcterms:created xsi:type="dcterms:W3CDTF">2020-05-21T03:28:06Z</dcterms:created>
  <dcterms:modified xsi:type="dcterms:W3CDTF">2020-05-21T03:31:57Z</dcterms:modified>
</cp:coreProperties>
</file>